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3F7B1C2-646A-45AD-B096-9012D2718F9C}" v="1" dt="2025-11-21T17:31:14.57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55" autoAdjust="0"/>
    <p:restoredTop sz="94660"/>
  </p:normalViewPr>
  <p:slideViewPr>
    <p:cSldViewPr snapToGrid="0">
      <p:cViewPr varScale="1">
        <p:scale>
          <a:sx n="43" d="100"/>
          <a:sy n="43" d="100"/>
        </p:scale>
        <p:origin x="54" y="5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ghan Moran" userId="30256bc4-a161-4226-a2d6-4e8766bd09d0" providerId="ADAL" clId="{8B0668C6-C7D0-4AFB-9B8E-773148CE68EF}"/>
    <pc:docChg chg="addSld delSld modSld">
      <pc:chgData name="Meghan Moran" userId="30256bc4-a161-4226-a2d6-4e8766bd09d0" providerId="ADAL" clId="{8B0668C6-C7D0-4AFB-9B8E-773148CE68EF}" dt="2025-11-21T17:31:16.306" v="1" actId="47"/>
      <pc:docMkLst>
        <pc:docMk/>
      </pc:docMkLst>
      <pc:sldChg chg="add">
        <pc:chgData name="Meghan Moran" userId="30256bc4-a161-4226-a2d6-4e8766bd09d0" providerId="ADAL" clId="{8B0668C6-C7D0-4AFB-9B8E-773148CE68EF}" dt="2025-11-21T17:31:14.573" v="0"/>
        <pc:sldMkLst>
          <pc:docMk/>
          <pc:sldMk cId="4147157069" sldId="367"/>
        </pc:sldMkLst>
      </pc:sldChg>
      <pc:sldChg chg="del">
        <pc:chgData name="Meghan Moran" userId="30256bc4-a161-4226-a2d6-4e8766bd09d0" providerId="ADAL" clId="{8B0668C6-C7D0-4AFB-9B8E-773148CE68EF}" dt="2025-11-21T17:31:16.306" v="1" actId="47"/>
        <pc:sldMkLst>
          <pc:docMk/>
          <pc:sldMk cId="3927049046" sldId="36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DC337-203F-6ACA-81AC-A8CD27A5AE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9D7B5D-55B0-0F5B-6BA0-DC90372DD4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04F32-11AA-CBE5-2813-45379BA1F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299BDA-A4D5-5426-1C32-74827FEEF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B5029E-681C-D8EA-A9CB-183241D8F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901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EB47E-F2C1-413F-B074-279E0D348F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D872DB-08DE-46C0-9BE7-C9EA6F70CF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F2B9D5-E42C-8729-D31B-A4C4FFFC2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023C39-0265-A664-15E0-F0096A2F5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B05800-E7E3-DEA3-F080-8507E4D9C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546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4666AB-3A2A-CAEC-CCB0-2D71536B3C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E2294C-2D59-A5D6-2BB4-5F224E22D2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8C372F-A7A7-E7B0-F777-9CFD14855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BE6756-259C-5BDB-275F-725DCB4E8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152E30-8BB8-6455-1F33-5535A5DF3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901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7A5150-CAE5-4302-4470-A41AD735A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25F923-B478-8748-7F7D-2781A5F69C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D437E4-8C26-5284-E89D-FACD8C431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B7BBD2-44EF-10AD-EA54-166AB146C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019E2B-FA57-B58C-DA85-FACDE38D7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352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4D0AF-E17E-151C-EE82-E6F69A538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EE6578-DA8B-EE9A-84AE-827EC7379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F4B51F-933B-BF26-83C2-3C0F127D0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3B3783-29CD-7E76-8B07-F52AFCF91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079BBE-A69E-4052-D46A-EFE735E63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462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678B95-B489-6691-A121-9CC6C4B712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C91E10-CD3D-3EDC-DFB0-803D967D56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333D40-635E-6ABB-1B03-872F3BE745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E6EE93-F983-49B8-E287-350ACD5A5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60D05B-83E8-E736-62CA-978BDAC89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93DB88-7FCA-805B-B25D-A15ED303A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058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2B4D2-B742-74AD-7E4F-1C36C8BF38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63AD43-55EA-D2A5-C714-0F0235245F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B4C5E5-8085-43E6-0982-479004178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4259B2-C329-5225-AFC6-1C45D9A86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7D774B-43D2-0E6E-192B-05B59342A2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031BED-9BF2-1594-9AF9-A8C3F8574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4B5B88-637B-2382-48A0-432B9BCA7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96C8DB-709D-927A-830E-6AA222BC3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174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449D5E-0BC9-365E-FBD0-5C50E02B1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96A71A-9EAC-E539-A92E-A8C4A2D89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358E02-2118-7788-D756-0079827477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31ED9F-AC4C-29FD-4CB8-C8FF1F5E6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472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886813-0D54-97B1-9E59-858D295EA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2F8018-E02D-A9CE-D719-36E85435A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90113A-1DA2-D8A0-5CA8-0ED75C829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972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43400C-96A9-3332-9F54-0E6371A59D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3E3DF7-C799-1095-64F8-E94B03841B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4E82F2-DA81-4ABB-2630-6746143C0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19D5D2-2449-89D1-2373-E4AF24D1C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9B6FAA-D7A8-C85A-18DA-83379ECCA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519064-18BA-1CDB-19AA-2A29554E3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188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287BDD-9463-3AED-548E-435A5322B0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4E64A2-3F6D-03EB-E76D-5046D5A6C0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43AA9C-110C-6439-5410-F3CF4C84BC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390388-7848-4138-531B-EF7F15E21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5C8E1D-B33D-C775-C3DB-16B67AF93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BB3E97-98B0-29A3-9A63-2EA4A8910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734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B1D7BD-CDAC-68DD-C607-2E71AB3D3F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BC608A-12FF-754B-AF73-6DDBDF80C9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5060F9-A318-F7D9-7F7A-431771AB91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A5AA70-A864-7D31-742F-E7BD4D0D15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1EC38-407C-52B9-1DA8-1E0EBDCB00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81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709811" y="1391923"/>
            <a:ext cx="3616830" cy="4692760"/>
            <a:chOff x="235982" y="138157"/>
            <a:chExt cx="3274473" cy="469276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5982" y="462455"/>
              <a:ext cx="3274473" cy="4368462"/>
            </a:xfrm>
            <a:prstGeom prst="rect">
              <a:avLst/>
            </a:prstGeom>
            <a:ln>
              <a:noFill/>
            </a:ln>
          </p:spPr>
        </p:pic>
        <p:sp>
          <p:nvSpPr>
            <p:cNvPr id="6" name="TextBox 5"/>
            <p:cNvSpPr txBox="1"/>
            <p:nvPr/>
          </p:nvSpPr>
          <p:spPr>
            <a:xfrm>
              <a:off x="1526610" y="198198"/>
              <a:ext cx="393056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3d</a:t>
              </a:r>
            </a:p>
          </p:txBody>
        </p:sp>
        <p:sp>
          <p:nvSpPr>
            <p:cNvPr id="7" name="Left Bracket 6"/>
            <p:cNvSpPr/>
            <p:nvPr/>
          </p:nvSpPr>
          <p:spPr>
            <a:xfrm rot="5400000">
              <a:off x="1707224" y="-1312064"/>
              <a:ext cx="220573" cy="3121016"/>
            </a:xfrm>
            <a:prstGeom prst="leftBracket">
              <a:avLst/>
            </a:prstGeom>
            <a:ln w="12700">
              <a:noFill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rcRect l="2130"/>
          <a:stretch/>
        </p:blipFill>
        <p:spPr>
          <a:xfrm>
            <a:off x="4515156" y="1737075"/>
            <a:ext cx="3139538" cy="4368462"/>
          </a:xfrm>
          <a:prstGeom prst="rect">
            <a:avLst/>
          </a:prstGeom>
          <a:ln>
            <a:noFill/>
          </a:ln>
        </p:spPr>
      </p:pic>
      <p:sp>
        <p:nvSpPr>
          <p:cNvPr id="9" name="Left Bracket 8"/>
          <p:cNvSpPr/>
          <p:nvPr/>
        </p:nvSpPr>
        <p:spPr>
          <a:xfrm rot="5400000">
            <a:off x="5920837" y="-162297"/>
            <a:ext cx="220574" cy="3038817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5547949" y="1233170"/>
            <a:ext cx="1140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resse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988669" y="1404866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8087980" y="1342428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ctivated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9910106" y="1349351"/>
            <a:ext cx="1140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resse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9089490" y="1404866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4d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42536" y="1757927"/>
            <a:ext cx="3616830" cy="4326756"/>
          </a:xfrm>
          <a:prstGeom prst="rect">
            <a:avLst/>
          </a:prstGeom>
          <a:ln>
            <a:noFill/>
          </a:ln>
        </p:spPr>
      </p:pic>
      <p:sp>
        <p:nvSpPr>
          <p:cNvPr id="19" name="TextBox 18"/>
          <p:cNvSpPr txBox="1"/>
          <p:nvPr/>
        </p:nvSpPr>
        <p:spPr>
          <a:xfrm>
            <a:off x="1028060" y="1347523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ctivated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960167" y="1347523"/>
            <a:ext cx="1140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ressed</a:t>
            </a:r>
          </a:p>
        </p:txBody>
      </p:sp>
      <p:sp>
        <p:nvSpPr>
          <p:cNvPr id="22" name="Left Bracket 21"/>
          <p:cNvSpPr/>
          <p:nvPr/>
        </p:nvSpPr>
        <p:spPr>
          <a:xfrm rot="5400000">
            <a:off x="2365462" y="-386794"/>
            <a:ext cx="267672" cy="3578973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Left Bracket 22"/>
          <p:cNvSpPr/>
          <p:nvPr/>
        </p:nvSpPr>
        <p:spPr>
          <a:xfrm rot="5400000">
            <a:off x="9380068" y="-422480"/>
            <a:ext cx="267672" cy="3578973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1950107" y="6084683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Ratio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601759" y="6135816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Ratio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8984658" y="6084683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Ratio</a:t>
            </a:r>
          </a:p>
        </p:txBody>
      </p:sp>
      <p:sp>
        <p:nvSpPr>
          <p:cNvPr id="28" name="Rectangle 27"/>
          <p:cNvSpPr/>
          <p:nvPr/>
        </p:nvSpPr>
        <p:spPr>
          <a:xfrm>
            <a:off x="0" y="118219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S9 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83014F7-80FC-DE4D-912C-23C804387350}"/>
              </a:ext>
            </a:extLst>
          </p:cNvPr>
          <p:cNvSpPr txBox="1"/>
          <p:nvPr/>
        </p:nvSpPr>
        <p:spPr>
          <a:xfrm>
            <a:off x="5111036" y="902715"/>
            <a:ext cx="19477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istal Colon- CFA</a:t>
            </a:r>
          </a:p>
        </p:txBody>
      </p:sp>
    </p:spTree>
    <p:extLst>
      <p:ext uri="{BB962C8B-B14F-4D97-AF65-F5344CB8AC3E}">
        <p14:creationId xmlns:p14="http://schemas.microsoft.com/office/powerpoint/2010/main" val="4147157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0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Rush University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ghan Moran</dc:creator>
  <cp:lastModifiedBy>Meghan Moran</cp:lastModifiedBy>
  <cp:revision>20</cp:revision>
  <dcterms:created xsi:type="dcterms:W3CDTF">2025-11-21T17:16:35Z</dcterms:created>
  <dcterms:modified xsi:type="dcterms:W3CDTF">2025-11-21T17:31:17Z</dcterms:modified>
</cp:coreProperties>
</file>